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8" r:id="rId5"/>
    <p:sldId id="259" r:id="rId6"/>
    <p:sldId id="260" r:id="rId7"/>
    <p:sldId id="261" r:id="rId8"/>
    <p:sldId id="262" r:id="rId9"/>
    <p:sldId id="263"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DEDED"/>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99B2AB6-6B1E-4E34-8EE8-D78F8AB30046}" v="7" dt="2021-02-09T04:51:11.961"/>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7" autoAdjust="0"/>
    <p:restoredTop sz="94660"/>
  </p:normalViewPr>
  <p:slideViewPr>
    <p:cSldViewPr snapToGrid="0">
      <p:cViewPr varScale="1">
        <p:scale>
          <a:sx n="77" d="100"/>
          <a:sy n="77" d="100"/>
        </p:scale>
        <p:origin x="132" y="81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2" Type="http://schemas.openxmlformats.org/officeDocument/2006/relationships/customXml" Target="../customXml/item2.xml"/><Relationship Id="rId16"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5" Type="http://schemas.microsoft.com/office/2016/11/relationships/changesInfo" Target="changesInfos/changesInfo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im, Antino" userId="5017172d-5e99-43c2-b1ea-89acf56c1c21" providerId="ADAL" clId="{899B2AB6-6B1E-4E34-8EE8-D78F8AB30046}"/>
    <pc:docChg chg="undo custSel modSld">
      <pc:chgData name="Kim, Antino" userId="5017172d-5e99-43c2-b1ea-89acf56c1c21" providerId="ADAL" clId="{899B2AB6-6B1E-4E34-8EE8-D78F8AB30046}" dt="2021-02-09T04:57:14.675" v="142" actId="1076"/>
      <pc:docMkLst>
        <pc:docMk/>
      </pc:docMkLst>
      <pc:sldChg chg="modSp mod">
        <pc:chgData name="Kim, Antino" userId="5017172d-5e99-43c2-b1ea-89acf56c1c21" providerId="ADAL" clId="{899B2AB6-6B1E-4E34-8EE8-D78F8AB30046}" dt="2021-02-09T04:55:04.376" v="125" actId="20577"/>
        <pc:sldMkLst>
          <pc:docMk/>
          <pc:sldMk cId="2855628911" sldId="258"/>
        </pc:sldMkLst>
        <pc:spChg chg="mod">
          <ac:chgData name="Kim, Antino" userId="5017172d-5e99-43c2-b1ea-89acf56c1c21" providerId="ADAL" clId="{899B2AB6-6B1E-4E34-8EE8-D78F8AB30046}" dt="2021-02-09T04:55:04.376" v="125" actId="20577"/>
          <ac:spMkLst>
            <pc:docMk/>
            <pc:sldMk cId="2855628911" sldId="258"/>
            <ac:spMk id="2" creationId="{00000000-0000-0000-0000-000000000000}"/>
          </ac:spMkLst>
        </pc:spChg>
        <pc:spChg chg="mod">
          <ac:chgData name="Kim, Antino" userId="5017172d-5e99-43c2-b1ea-89acf56c1c21" providerId="ADAL" clId="{899B2AB6-6B1E-4E34-8EE8-D78F8AB30046}" dt="2021-02-09T04:32:42.427" v="25" actId="1036"/>
          <ac:spMkLst>
            <pc:docMk/>
            <pc:sldMk cId="2855628911" sldId="258"/>
            <ac:spMk id="8" creationId="{A86C3B6D-BBF2-4D76-AA42-8F76546CF938}"/>
          </ac:spMkLst>
        </pc:spChg>
        <pc:spChg chg="mod">
          <ac:chgData name="Kim, Antino" userId="5017172d-5e99-43c2-b1ea-89acf56c1c21" providerId="ADAL" clId="{899B2AB6-6B1E-4E34-8EE8-D78F8AB30046}" dt="2021-02-09T04:32:42.427" v="25" actId="1036"/>
          <ac:spMkLst>
            <pc:docMk/>
            <pc:sldMk cId="2855628911" sldId="258"/>
            <ac:spMk id="11" creationId="{3F2A3541-63C5-4CC5-B2CF-44A45F143580}"/>
          </ac:spMkLst>
        </pc:spChg>
        <pc:spChg chg="mod">
          <ac:chgData name="Kim, Antino" userId="5017172d-5e99-43c2-b1ea-89acf56c1c21" providerId="ADAL" clId="{899B2AB6-6B1E-4E34-8EE8-D78F8AB30046}" dt="2021-02-09T04:32:42.427" v="25" actId="1036"/>
          <ac:spMkLst>
            <pc:docMk/>
            <pc:sldMk cId="2855628911" sldId="258"/>
            <ac:spMk id="13" creationId="{71D12E87-0CC5-43DA-B7AF-22A12495C683}"/>
          </ac:spMkLst>
        </pc:spChg>
        <pc:spChg chg="mod">
          <ac:chgData name="Kim, Antino" userId="5017172d-5e99-43c2-b1ea-89acf56c1c21" providerId="ADAL" clId="{899B2AB6-6B1E-4E34-8EE8-D78F8AB30046}" dt="2021-02-09T04:32:42.427" v="25" actId="1036"/>
          <ac:spMkLst>
            <pc:docMk/>
            <pc:sldMk cId="2855628911" sldId="258"/>
            <ac:spMk id="14" creationId="{2A261E3E-0B6F-40E7-BC65-0425B81B27BC}"/>
          </ac:spMkLst>
        </pc:spChg>
      </pc:sldChg>
      <pc:sldChg chg="addSp delSp modSp mod">
        <pc:chgData name="Kim, Antino" userId="5017172d-5e99-43c2-b1ea-89acf56c1c21" providerId="ADAL" clId="{899B2AB6-6B1E-4E34-8EE8-D78F8AB30046}" dt="2021-02-09T04:39:09.002" v="73" actId="1037"/>
        <pc:sldMkLst>
          <pc:docMk/>
          <pc:sldMk cId="1133658276" sldId="259"/>
        </pc:sldMkLst>
        <pc:spChg chg="add del mod">
          <ac:chgData name="Kim, Antino" userId="5017172d-5e99-43c2-b1ea-89acf56c1c21" providerId="ADAL" clId="{899B2AB6-6B1E-4E34-8EE8-D78F8AB30046}" dt="2021-02-09T04:38:47.646" v="69" actId="478"/>
          <ac:spMkLst>
            <pc:docMk/>
            <pc:sldMk cId="1133658276" sldId="259"/>
            <ac:spMk id="9" creationId="{80F990DE-C7EF-438D-97F7-61DF1DD1C0D0}"/>
          </ac:spMkLst>
        </pc:spChg>
        <pc:spChg chg="del mod">
          <ac:chgData name="Kim, Antino" userId="5017172d-5e99-43c2-b1ea-89acf56c1c21" providerId="ADAL" clId="{899B2AB6-6B1E-4E34-8EE8-D78F8AB30046}" dt="2021-02-09T04:38:57.461" v="70" actId="478"/>
          <ac:spMkLst>
            <pc:docMk/>
            <pc:sldMk cId="1133658276" sldId="259"/>
            <ac:spMk id="10" creationId="{3F2A3541-63C5-4CC5-B2CF-44A45F143580}"/>
          </ac:spMkLst>
        </pc:spChg>
        <pc:spChg chg="add mod">
          <ac:chgData name="Kim, Antino" userId="5017172d-5e99-43c2-b1ea-89acf56c1c21" providerId="ADAL" clId="{899B2AB6-6B1E-4E34-8EE8-D78F8AB30046}" dt="2021-02-09T04:38:57.740" v="71"/>
          <ac:spMkLst>
            <pc:docMk/>
            <pc:sldMk cId="1133658276" sldId="259"/>
            <ac:spMk id="12" creationId="{F868A25C-9DF9-4EC1-B915-67F123A588B9}"/>
          </ac:spMkLst>
        </pc:spChg>
        <pc:spChg chg="mod">
          <ac:chgData name="Kim, Antino" userId="5017172d-5e99-43c2-b1ea-89acf56c1c21" providerId="ADAL" clId="{899B2AB6-6B1E-4E34-8EE8-D78F8AB30046}" dt="2021-02-09T04:38:44.565" v="68" actId="1036"/>
          <ac:spMkLst>
            <pc:docMk/>
            <pc:sldMk cId="1133658276" sldId="259"/>
            <ac:spMk id="13" creationId="{C3128224-6AA1-4284-A1A4-55614433B981}"/>
          </ac:spMkLst>
        </pc:spChg>
        <pc:spChg chg="del mod">
          <ac:chgData name="Kim, Antino" userId="5017172d-5e99-43c2-b1ea-89acf56c1c21" providerId="ADAL" clId="{899B2AB6-6B1E-4E34-8EE8-D78F8AB30046}" dt="2021-02-09T04:38:57.461" v="70" actId="478"/>
          <ac:spMkLst>
            <pc:docMk/>
            <pc:sldMk cId="1133658276" sldId="259"/>
            <ac:spMk id="14" creationId="{71D12E87-0CC5-43DA-B7AF-22A12495C683}"/>
          </ac:spMkLst>
        </pc:spChg>
        <pc:spChg chg="del mod">
          <ac:chgData name="Kim, Antino" userId="5017172d-5e99-43c2-b1ea-89acf56c1c21" providerId="ADAL" clId="{899B2AB6-6B1E-4E34-8EE8-D78F8AB30046}" dt="2021-02-09T04:38:57.461" v="70" actId="478"/>
          <ac:spMkLst>
            <pc:docMk/>
            <pc:sldMk cId="1133658276" sldId="259"/>
            <ac:spMk id="15" creationId="{2A261E3E-0B6F-40E7-BC65-0425B81B27BC}"/>
          </ac:spMkLst>
        </pc:spChg>
        <pc:spChg chg="add mod">
          <ac:chgData name="Kim, Antino" userId="5017172d-5e99-43c2-b1ea-89acf56c1c21" providerId="ADAL" clId="{899B2AB6-6B1E-4E34-8EE8-D78F8AB30046}" dt="2021-02-09T04:38:57.740" v="71"/>
          <ac:spMkLst>
            <pc:docMk/>
            <pc:sldMk cId="1133658276" sldId="259"/>
            <ac:spMk id="16" creationId="{44890E83-06AE-42E4-B7D0-BA1212712C9C}"/>
          </ac:spMkLst>
        </pc:spChg>
        <pc:spChg chg="add mod">
          <ac:chgData name="Kim, Antino" userId="5017172d-5e99-43c2-b1ea-89acf56c1c21" providerId="ADAL" clId="{899B2AB6-6B1E-4E34-8EE8-D78F8AB30046}" dt="2021-02-09T04:38:57.740" v="71"/>
          <ac:spMkLst>
            <pc:docMk/>
            <pc:sldMk cId="1133658276" sldId="259"/>
            <ac:spMk id="17" creationId="{E36D2A76-148D-4F23-AC49-87FE655DB459}"/>
          </ac:spMkLst>
        </pc:spChg>
        <pc:picChg chg="mod">
          <ac:chgData name="Kim, Antino" userId="5017172d-5e99-43c2-b1ea-89acf56c1c21" providerId="ADAL" clId="{899B2AB6-6B1E-4E34-8EE8-D78F8AB30046}" dt="2021-02-09T04:39:09.002" v="73" actId="1037"/>
          <ac:picMkLst>
            <pc:docMk/>
            <pc:sldMk cId="1133658276" sldId="259"/>
            <ac:picMk id="11" creationId="{2145A697-8BE9-4E0F-ADB6-FC43CF275420}"/>
          </ac:picMkLst>
        </pc:picChg>
      </pc:sldChg>
      <pc:sldChg chg="addSp delSp modSp mod">
        <pc:chgData name="Kim, Antino" userId="5017172d-5e99-43c2-b1ea-89acf56c1c21" providerId="ADAL" clId="{899B2AB6-6B1E-4E34-8EE8-D78F8AB30046}" dt="2021-02-09T04:37:10.769" v="62" actId="20577"/>
        <pc:sldMkLst>
          <pc:docMk/>
          <pc:sldMk cId="1944870842" sldId="260"/>
        </pc:sldMkLst>
        <pc:spChg chg="mod">
          <ac:chgData name="Kim, Antino" userId="5017172d-5e99-43c2-b1ea-89acf56c1c21" providerId="ADAL" clId="{899B2AB6-6B1E-4E34-8EE8-D78F8AB30046}" dt="2021-02-09T04:36:37.238" v="59" actId="1076"/>
          <ac:spMkLst>
            <pc:docMk/>
            <pc:sldMk cId="1944870842" sldId="260"/>
            <ac:spMk id="4" creationId="{A86C3B6D-BBF2-4D76-AA42-8F76546CF938}"/>
          </ac:spMkLst>
        </pc:spChg>
        <pc:spChg chg="mod">
          <ac:chgData name="Kim, Antino" userId="5017172d-5e99-43c2-b1ea-89acf56c1c21" providerId="ADAL" clId="{899B2AB6-6B1E-4E34-8EE8-D78F8AB30046}" dt="2021-02-09T04:37:10.769" v="62" actId="20577"/>
          <ac:spMkLst>
            <pc:docMk/>
            <pc:sldMk cId="1944870842" sldId="260"/>
            <ac:spMk id="5" creationId="{B9D21F70-F164-4EBE-81F5-7A4D1FDC552C}"/>
          </ac:spMkLst>
        </pc:spChg>
        <pc:spChg chg="add del mod">
          <ac:chgData name="Kim, Antino" userId="5017172d-5e99-43c2-b1ea-89acf56c1c21" providerId="ADAL" clId="{899B2AB6-6B1E-4E34-8EE8-D78F8AB30046}" dt="2021-02-09T04:36:40.126" v="60" actId="478"/>
          <ac:spMkLst>
            <pc:docMk/>
            <pc:sldMk cId="1944870842" sldId="260"/>
            <ac:spMk id="6" creationId="{9BBA4659-2C9D-4203-8BD0-82827A80EE0C}"/>
          </ac:spMkLst>
        </pc:spChg>
      </pc:sldChg>
      <pc:sldChg chg="modSp mod">
        <pc:chgData name="Kim, Antino" userId="5017172d-5e99-43c2-b1ea-89acf56c1c21" providerId="ADAL" clId="{899B2AB6-6B1E-4E34-8EE8-D78F8AB30046}" dt="2021-02-09T04:36:18.250" v="56" actId="1076"/>
        <pc:sldMkLst>
          <pc:docMk/>
          <pc:sldMk cId="1511986983" sldId="261"/>
        </pc:sldMkLst>
        <pc:spChg chg="mod">
          <ac:chgData name="Kim, Antino" userId="5017172d-5e99-43c2-b1ea-89acf56c1c21" providerId="ADAL" clId="{899B2AB6-6B1E-4E34-8EE8-D78F8AB30046}" dt="2021-02-09T04:36:18.250" v="56" actId="1076"/>
          <ac:spMkLst>
            <pc:docMk/>
            <pc:sldMk cId="1511986983" sldId="261"/>
            <ac:spMk id="4" creationId="{A86C3B6D-BBF2-4D76-AA42-8F76546CF938}"/>
          </ac:spMkLst>
        </pc:spChg>
        <pc:spChg chg="mod">
          <ac:chgData name="Kim, Antino" userId="5017172d-5e99-43c2-b1ea-89acf56c1c21" providerId="ADAL" clId="{899B2AB6-6B1E-4E34-8EE8-D78F8AB30046}" dt="2021-02-09T04:35:52.159" v="53" actId="1076"/>
          <ac:spMkLst>
            <pc:docMk/>
            <pc:sldMk cId="1511986983" sldId="261"/>
            <ac:spMk id="5" creationId="{B9D21F70-F164-4EBE-81F5-7A4D1FDC552C}"/>
          </ac:spMkLst>
        </pc:spChg>
      </pc:sldChg>
      <pc:sldChg chg="addSp delSp modSp mod">
        <pc:chgData name="Kim, Antino" userId="5017172d-5e99-43c2-b1ea-89acf56c1c21" providerId="ADAL" clId="{899B2AB6-6B1E-4E34-8EE8-D78F8AB30046}" dt="2021-02-09T04:57:14.675" v="142" actId="1076"/>
        <pc:sldMkLst>
          <pc:docMk/>
          <pc:sldMk cId="818358744" sldId="262"/>
        </pc:sldMkLst>
        <pc:spChg chg="add del mod">
          <ac:chgData name="Kim, Antino" userId="5017172d-5e99-43c2-b1ea-89acf56c1c21" providerId="ADAL" clId="{899B2AB6-6B1E-4E34-8EE8-D78F8AB30046}" dt="2021-02-09T04:50:04.989" v="79"/>
          <ac:spMkLst>
            <pc:docMk/>
            <pc:sldMk cId="818358744" sldId="262"/>
            <ac:spMk id="3" creationId="{E4AB01F9-F294-4683-AD1F-60685AAC311C}"/>
          </ac:spMkLst>
        </pc:spChg>
        <pc:spChg chg="mod">
          <ac:chgData name="Kim, Antino" userId="5017172d-5e99-43c2-b1ea-89acf56c1c21" providerId="ADAL" clId="{899B2AB6-6B1E-4E34-8EE8-D78F8AB30046}" dt="2021-02-09T04:55:55.560" v="131" actId="20577"/>
          <ac:spMkLst>
            <pc:docMk/>
            <pc:sldMk cId="818358744" sldId="262"/>
            <ac:spMk id="5" creationId="{00000000-0000-0000-0000-000000000000}"/>
          </ac:spMkLst>
        </pc:spChg>
        <pc:spChg chg="mod">
          <ac:chgData name="Kim, Antino" userId="5017172d-5e99-43c2-b1ea-89acf56c1c21" providerId="ADAL" clId="{899B2AB6-6B1E-4E34-8EE8-D78F8AB30046}" dt="2021-02-09T04:52:14.879" v="106" actId="1076"/>
          <ac:spMkLst>
            <pc:docMk/>
            <pc:sldMk cId="818358744" sldId="262"/>
            <ac:spMk id="7" creationId="{A86C3B6D-BBF2-4D76-AA42-8F76546CF938}"/>
          </ac:spMkLst>
        </pc:spChg>
        <pc:graphicFrameChg chg="add del mod">
          <ac:chgData name="Kim, Antino" userId="5017172d-5e99-43c2-b1ea-89acf56c1c21" providerId="ADAL" clId="{899B2AB6-6B1E-4E34-8EE8-D78F8AB30046}" dt="2021-02-09T04:50:04.989" v="79"/>
          <ac:graphicFrameMkLst>
            <pc:docMk/>
            <pc:sldMk cId="818358744" sldId="262"/>
            <ac:graphicFrameMk id="2" creationId="{D78C9CC9-0514-42BE-89B5-3234B7AFD4C4}"/>
          </ac:graphicFrameMkLst>
        </pc:graphicFrameChg>
        <pc:graphicFrameChg chg="del mod modGraphic">
          <ac:chgData name="Kim, Antino" userId="5017172d-5e99-43c2-b1ea-89acf56c1c21" providerId="ADAL" clId="{899B2AB6-6B1E-4E34-8EE8-D78F8AB30046}" dt="2021-02-09T04:49:57.661" v="77" actId="478"/>
          <ac:graphicFrameMkLst>
            <pc:docMk/>
            <pc:sldMk cId="818358744" sldId="262"/>
            <ac:graphicFrameMk id="6" creationId="{00000000-0000-0000-0000-000000000000}"/>
          </ac:graphicFrameMkLst>
        </pc:graphicFrameChg>
        <pc:picChg chg="add del mod modCrop">
          <ac:chgData name="Kim, Antino" userId="5017172d-5e99-43c2-b1ea-89acf56c1c21" providerId="ADAL" clId="{899B2AB6-6B1E-4E34-8EE8-D78F8AB30046}" dt="2021-02-09T04:51:09.633" v="88" actId="478"/>
          <ac:picMkLst>
            <pc:docMk/>
            <pc:sldMk cId="818358744" sldId="262"/>
            <ac:picMk id="4" creationId="{404BA4A4-4AD1-43B5-B4DA-A9C03A7D3020}"/>
          </ac:picMkLst>
        </pc:picChg>
        <pc:picChg chg="add mod modCrop">
          <ac:chgData name="Kim, Antino" userId="5017172d-5e99-43c2-b1ea-89acf56c1c21" providerId="ADAL" clId="{899B2AB6-6B1E-4E34-8EE8-D78F8AB30046}" dt="2021-02-09T04:57:14.675" v="142" actId="1076"/>
          <ac:picMkLst>
            <pc:docMk/>
            <pc:sldMk cId="818358744" sldId="262"/>
            <ac:picMk id="8" creationId="{9115673C-CB0E-4756-936B-873DD3D3C917}"/>
          </ac:picMkLst>
        </pc:picChg>
      </pc:sldChg>
      <pc:sldChg chg="modSp mod">
        <pc:chgData name="Kim, Antino" userId="5017172d-5e99-43c2-b1ea-89acf56c1c21" providerId="ADAL" clId="{899B2AB6-6B1E-4E34-8EE8-D78F8AB30046}" dt="2021-02-09T04:33:38.573" v="29" actId="1076"/>
        <pc:sldMkLst>
          <pc:docMk/>
          <pc:sldMk cId="1086213433" sldId="263"/>
        </pc:sldMkLst>
        <pc:spChg chg="mod">
          <ac:chgData name="Kim, Antino" userId="5017172d-5e99-43c2-b1ea-89acf56c1c21" providerId="ADAL" clId="{899B2AB6-6B1E-4E34-8EE8-D78F8AB30046}" dt="2021-02-09T04:33:38.573" v="29" actId="1076"/>
          <ac:spMkLst>
            <pc:docMk/>
            <pc:sldMk cId="1086213433" sldId="263"/>
            <ac:spMk id="2" creationId="{00000000-0000-0000-0000-000000000000}"/>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AFA0E2-F073-4214-9E11-E22FE183F35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E1FB321-0AD9-4EB3-9C9D-BF70F8B926A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1DF7E08-3781-4063-BDEC-6B87674D04EC}"/>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A5E8BF23-8093-4FF6-A9A5-458B5A9F90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893005-7133-4AB0-A0B4-99CE87AF8D79}"/>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10326692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6296C6-C401-426E-86D9-B9524110B5B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774A884-2429-4D22-A398-5728D8F377C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C9AB58-5E09-447D-85DB-DF971A6CC9C6}"/>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B4E0C74F-EAD3-4934-8594-221A47EBEE9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FA8264-3372-4B9B-A1F1-7B8274B65208}"/>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4088043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DA070F7-DE2A-426E-BF17-C171BD2C1B5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4763831-D730-4773-8B43-42FF53BFA02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238D5F-F158-417F-B0AE-D300BAB86058}"/>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AA180C00-D55C-4D56-8E21-93D77A8FA98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090846-7C74-4ACD-B2CF-909D00449D90}"/>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6455151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2455B2-864A-4972-A062-8CBB139F67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F9F7F8E-5FA9-40A9-BED4-02DEDA93D1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9C5099-A124-49EB-B6E5-7FC256DFE41C}"/>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0E8E63DA-3E16-43C0-96C4-BB2A05625C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09CF4A-9B69-4CBF-AF56-245C8A08FA80}"/>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7577844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40D2D7-A8B7-4B52-A6D1-9BD1568C22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5AEEF3C-B18E-4C2D-8387-B33C65AE3EC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1C13242-05F2-43C7-A651-03CA9F23D4EB}"/>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8F1CE2DC-1B29-4CBD-B7E0-0A4AC85A91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31BDDA-3F1F-4848-A71E-B1885F23B1D2}"/>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2655130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E40D5C-3E7B-4105-9E53-D06612DDAA7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0048E0-CB07-4AE8-BE4F-D8D946C2AE8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C08DC65-8A3B-4236-8BE9-4EA61254827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98B5FFC-966B-4E32-AE2B-A567D371BAB9}"/>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6" name="Footer Placeholder 5">
            <a:extLst>
              <a:ext uri="{FF2B5EF4-FFF2-40B4-BE49-F238E27FC236}">
                <a16:creationId xmlns:a16="http://schemas.microsoft.com/office/drawing/2014/main" id="{6DC1C250-185B-4ABC-BAF2-64E54323FC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CE8D57-93B2-4496-8783-9A4B73F478F2}"/>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27686748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6D89DE-E6BB-43D3-8741-AC8FC1AA1EA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0B12E13-FA29-49D9-A50E-E84B01FED4F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F06EE6E-0706-4BCA-B63E-D727BF44CCC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CDE9D40-EE35-4D37-8FFD-F249F4DDFC3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7AE7EC8-7EE8-4009-93E0-4249E01B63D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38D6AFE-A0B9-4B06-AE12-11D524456671}"/>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8" name="Footer Placeholder 7">
            <a:extLst>
              <a:ext uri="{FF2B5EF4-FFF2-40B4-BE49-F238E27FC236}">
                <a16:creationId xmlns:a16="http://schemas.microsoft.com/office/drawing/2014/main" id="{577AB886-D643-4FA9-BFC2-E50078D3A34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437DA46-0EE9-46A5-A19A-2CD574534951}"/>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36874563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55253C-867C-4F17-9C11-C0EC45E92DC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87D1CAF-A40D-4B19-B680-4EC9490D08E2}"/>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4" name="Footer Placeholder 3">
            <a:extLst>
              <a:ext uri="{FF2B5EF4-FFF2-40B4-BE49-F238E27FC236}">
                <a16:creationId xmlns:a16="http://schemas.microsoft.com/office/drawing/2014/main" id="{04B47C6F-A223-4303-B327-BF12747F53A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6C09C66-6BAD-4CFE-BB18-97D1BF3D3B3E}"/>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2139887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3AB6847-9098-436E-BD2B-875C537CFEEF}"/>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3" name="Footer Placeholder 2">
            <a:extLst>
              <a:ext uri="{FF2B5EF4-FFF2-40B4-BE49-F238E27FC236}">
                <a16:creationId xmlns:a16="http://schemas.microsoft.com/office/drawing/2014/main" id="{BFCEC868-5C1C-41FE-AFD2-6F2FB48301D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E96B1CB-8E17-4C61-8D11-4B671F2A342B}"/>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39404762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4EBF5-C252-4586-AD3B-1876A6EC9C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25A3D1E-2DBE-473D-9BA1-1B12D8E0423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2B3FE90-3F08-4EFD-9ADE-4DF3645CFC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3F16C05-A115-41A5-8D1B-EBF04EB890CD}"/>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6" name="Footer Placeholder 5">
            <a:extLst>
              <a:ext uri="{FF2B5EF4-FFF2-40B4-BE49-F238E27FC236}">
                <a16:creationId xmlns:a16="http://schemas.microsoft.com/office/drawing/2014/main" id="{A614A559-9952-4D39-A126-A309C8EDE6B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093192C-E7BB-42CE-90C4-0484FD408F9E}"/>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934037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0ECCCD-3BAF-414F-A703-1E323539CE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9EF2E8A-7FF4-421F-84DB-5D71A4AD7CE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3BD4BFA-74EF-466E-9521-604C8695CD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F60CEFE-7E75-4DAD-9962-00572774F035}"/>
              </a:ext>
            </a:extLst>
          </p:cNvPr>
          <p:cNvSpPr>
            <a:spLocks noGrp="1"/>
          </p:cNvSpPr>
          <p:nvPr>
            <p:ph type="dt" sz="half" idx="10"/>
          </p:nvPr>
        </p:nvSpPr>
        <p:spPr/>
        <p:txBody>
          <a:bodyPr/>
          <a:lstStyle/>
          <a:p>
            <a:fld id="{6822E8EE-04F6-45B9-BEFF-1C75A42D4647}" type="datetimeFigureOut">
              <a:rPr lang="en-US" smtClean="0"/>
              <a:t>2/9/2021</a:t>
            </a:fld>
            <a:endParaRPr lang="en-US"/>
          </a:p>
        </p:txBody>
      </p:sp>
      <p:sp>
        <p:nvSpPr>
          <p:cNvPr id="6" name="Footer Placeholder 5">
            <a:extLst>
              <a:ext uri="{FF2B5EF4-FFF2-40B4-BE49-F238E27FC236}">
                <a16:creationId xmlns:a16="http://schemas.microsoft.com/office/drawing/2014/main" id="{07BC6CB7-952D-4BAF-B621-F3D5A984B3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2010E04-44CC-43FA-953E-FDB119227539}"/>
              </a:ext>
            </a:extLst>
          </p:cNvPr>
          <p:cNvSpPr>
            <a:spLocks noGrp="1"/>
          </p:cNvSpPr>
          <p:nvPr>
            <p:ph type="sldNum" sz="quarter" idx="12"/>
          </p:nvPr>
        </p:nvSpPr>
        <p:spPr/>
        <p:txBody>
          <a:bodyPr/>
          <a:lstStyle/>
          <a:p>
            <a:fld id="{1373F7DC-3B13-477D-ACAB-EF51DFD48300}" type="slidenum">
              <a:rPr lang="en-US" smtClean="0"/>
              <a:t>‹#›</a:t>
            </a:fld>
            <a:endParaRPr lang="en-US"/>
          </a:p>
        </p:txBody>
      </p:sp>
    </p:spTree>
    <p:extLst>
      <p:ext uri="{BB962C8B-B14F-4D97-AF65-F5344CB8AC3E}">
        <p14:creationId xmlns:p14="http://schemas.microsoft.com/office/powerpoint/2010/main" val="13626433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B4CEB5A-D811-448F-A3E7-A2E73047B5D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64F2C08-B9AA-4B1E-81F8-D00C22B32D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82B0C97-4F30-4857-BAB2-9978CE41DC4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822E8EE-04F6-45B9-BEFF-1C75A42D4647}" type="datetimeFigureOut">
              <a:rPr lang="en-US" smtClean="0"/>
              <a:t>2/9/2021</a:t>
            </a:fld>
            <a:endParaRPr lang="en-US"/>
          </a:p>
        </p:txBody>
      </p:sp>
      <p:sp>
        <p:nvSpPr>
          <p:cNvPr id="5" name="Footer Placeholder 4">
            <a:extLst>
              <a:ext uri="{FF2B5EF4-FFF2-40B4-BE49-F238E27FC236}">
                <a16:creationId xmlns:a16="http://schemas.microsoft.com/office/drawing/2014/main" id="{FD609FEA-8C9E-4FC4-AC44-578E3FEFF3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7B66DEF-BFEA-4F90-BC10-9DF43BCC22A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73F7DC-3B13-477D-ACAB-EF51DFD48300}" type="slidenum">
              <a:rPr lang="en-US" smtClean="0"/>
              <a:t>‹#›</a:t>
            </a:fld>
            <a:endParaRPr lang="en-US"/>
          </a:p>
        </p:txBody>
      </p:sp>
    </p:spTree>
    <p:extLst>
      <p:ext uri="{BB962C8B-B14F-4D97-AF65-F5344CB8AC3E}">
        <p14:creationId xmlns:p14="http://schemas.microsoft.com/office/powerpoint/2010/main" val="40246418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Text, letter&#10;&#10;Description automatically generated">
            <a:extLst>
              <a:ext uri="{FF2B5EF4-FFF2-40B4-BE49-F238E27FC236}">
                <a16:creationId xmlns:a16="http://schemas.microsoft.com/office/drawing/2014/main" id="{E213B741-17CB-412D-9F8D-0A368B202E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885599" y="2056684"/>
            <a:ext cx="3581900" cy="4220164"/>
          </a:xfrm>
          <a:prstGeom prst="rect">
            <a:avLst/>
          </a:prstGeom>
        </p:spPr>
      </p:pic>
      <p:pic>
        <p:nvPicPr>
          <p:cNvPr id="12" name="Picture 11" descr="Text, letter&#10;&#10;Description automatically generated">
            <a:extLst>
              <a:ext uri="{FF2B5EF4-FFF2-40B4-BE49-F238E27FC236}">
                <a16:creationId xmlns:a16="http://schemas.microsoft.com/office/drawing/2014/main" id="{EFF1CB30-065D-4412-B6A7-97D1061180C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56067" y="2051921"/>
            <a:ext cx="3629532" cy="4229690"/>
          </a:xfrm>
          <a:prstGeom prst="rect">
            <a:avLst/>
          </a:prstGeom>
        </p:spPr>
      </p:pic>
      <p:sp>
        <p:nvSpPr>
          <p:cNvPr id="8" name="TextBox 7">
            <a:extLst>
              <a:ext uri="{FF2B5EF4-FFF2-40B4-BE49-F238E27FC236}">
                <a16:creationId xmlns:a16="http://schemas.microsoft.com/office/drawing/2014/main" id="{A86C3B6D-BBF2-4D76-AA42-8F76546CF938}"/>
              </a:ext>
            </a:extLst>
          </p:cNvPr>
          <p:cNvSpPr txBox="1"/>
          <p:nvPr/>
        </p:nvSpPr>
        <p:spPr>
          <a:xfrm>
            <a:off x="642286" y="1293165"/>
            <a:ext cx="259626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A1. </a:t>
            </a:r>
            <a:r>
              <a:rPr lang="en-US" sz="1600" dirty="0">
                <a:latin typeface="Times New Roman" panose="02020603050405020304" pitchFamily="18" charset="0"/>
                <a:cs typeface="Times New Roman" panose="02020603050405020304" pitchFamily="18" charset="0"/>
              </a:rPr>
              <a:t>Mask Treatments</a:t>
            </a:r>
          </a:p>
        </p:txBody>
      </p:sp>
      <p:sp>
        <p:nvSpPr>
          <p:cNvPr id="11" name="TextBox 10">
            <a:extLst>
              <a:ext uri="{FF2B5EF4-FFF2-40B4-BE49-F238E27FC236}">
                <a16:creationId xmlns:a16="http://schemas.microsoft.com/office/drawing/2014/main" id="{3F2A3541-63C5-4CC5-B2CF-44A45F143580}"/>
              </a:ext>
            </a:extLst>
          </p:cNvPr>
          <p:cNvSpPr txBox="1"/>
          <p:nvPr/>
        </p:nvSpPr>
        <p:spPr>
          <a:xfrm>
            <a:off x="1346137" y="1745118"/>
            <a:ext cx="2064884"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 Christian-Framed</a:t>
            </a:r>
          </a:p>
        </p:txBody>
      </p:sp>
      <p:sp>
        <p:nvSpPr>
          <p:cNvPr id="13" name="TextBox 12">
            <a:extLst>
              <a:ext uri="{FF2B5EF4-FFF2-40B4-BE49-F238E27FC236}">
                <a16:creationId xmlns:a16="http://schemas.microsoft.com/office/drawing/2014/main" id="{71D12E87-0CC5-43DA-B7AF-22A12495C683}"/>
              </a:ext>
            </a:extLst>
          </p:cNvPr>
          <p:cNvSpPr txBox="1"/>
          <p:nvPr/>
        </p:nvSpPr>
        <p:spPr>
          <a:xfrm>
            <a:off x="5004276" y="1745118"/>
            <a:ext cx="219195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 Economy-Framed</a:t>
            </a:r>
          </a:p>
        </p:txBody>
      </p:sp>
      <p:sp>
        <p:nvSpPr>
          <p:cNvPr id="14" name="TextBox 13">
            <a:extLst>
              <a:ext uri="{FF2B5EF4-FFF2-40B4-BE49-F238E27FC236}">
                <a16:creationId xmlns:a16="http://schemas.microsoft.com/office/drawing/2014/main" id="{2A261E3E-0B6F-40E7-BC65-0425B81B27BC}"/>
              </a:ext>
            </a:extLst>
          </p:cNvPr>
          <p:cNvSpPr txBox="1"/>
          <p:nvPr/>
        </p:nvSpPr>
        <p:spPr>
          <a:xfrm>
            <a:off x="9032073" y="1745118"/>
            <a:ext cx="128895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c) Control</a:t>
            </a:r>
          </a:p>
        </p:txBody>
      </p:sp>
      <p:sp>
        <p:nvSpPr>
          <p:cNvPr id="2" name="Rectangle 1"/>
          <p:cNvSpPr/>
          <p:nvPr/>
        </p:nvSpPr>
        <p:spPr>
          <a:xfrm>
            <a:off x="608730" y="188557"/>
            <a:ext cx="10983048" cy="619272"/>
          </a:xfrm>
          <a:prstGeom prst="rect">
            <a:avLst/>
          </a:prstGeom>
        </p:spPr>
        <p:txBody>
          <a:bodyPr wrap="square">
            <a:spAutoFit/>
          </a:bodyPr>
          <a:lstStyle/>
          <a:p>
            <a:pPr>
              <a:lnSpc>
                <a:spcPct val="107000"/>
              </a:lnSpc>
              <a:spcAft>
                <a:spcPts val="800"/>
              </a:spcAft>
            </a:pPr>
            <a:r>
              <a:rPr lang="en-US" sz="1600" i="1" u="sng" dirty="0">
                <a:solidFill>
                  <a:srgbClr val="333333"/>
                </a:solidFill>
                <a:latin typeface="Times New Roman" panose="02020603050405020304" pitchFamily="18" charset="0"/>
                <a:ea typeface="Times New Roman" panose="02020603050405020304" pitchFamily="18" charset="0"/>
                <a:cs typeface="Times New Roman" panose="02020603050405020304" pitchFamily="18" charset="0"/>
              </a:rPr>
              <a:t>Note</a:t>
            </a:r>
            <a:r>
              <a:rPr lang="en-US" sz="1600" i="1" dirty="0">
                <a:solidFill>
                  <a:srgbClr val="333333"/>
                </a:solidFill>
                <a:latin typeface="Times New Roman" panose="02020603050405020304" pitchFamily="18" charset="0"/>
                <a:ea typeface="Times New Roman" panose="02020603050405020304" pitchFamily="18" charset="0"/>
                <a:cs typeface="Times New Roman" panose="02020603050405020304" pitchFamily="18" charset="0"/>
              </a:rPr>
              <a:t>: This is a Multimedia Appendix to a full manuscript published in the J Med Internet Res. For full copyright and citation information, see [TO BE FILLED].</a:t>
            </a:r>
            <a:endParaRPr lang="en-US" sz="1600" i="1" dirty="0">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6" name="Picture 5" descr="Text&#10;&#10;Description automatically generated">
            <a:extLst>
              <a:ext uri="{FF2B5EF4-FFF2-40B4-BE49-F238E27FC236}">
                <a16:creationId xmlns:a16="http://schemas.microsoft.com/office/drawing/2014/main" id="{AB81848F-2B22-4F64-9E99-AE9F80F9868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3884" y="2061447"/>
            <a:ext cx="3591426" cy="4220164"/>
          </a:xfrm>
          <a:prstGeom prst="rect">
            <a:avLst/>
          </a:prstGeom>
        </p:spPr>
      </p:pic>
    </p:spTree>
    <p:extLst>
      <p:ext uri="{BB962C8B-B14F-4D97-AF65-F5344CB8AC3E}">
        <p14:creationId xmlns:p14="http://schemas.microsoft.com/office/powerpoint/2010/main" val="28556289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Text, letter&#10;&#10;Description automatically generated">
            <a:extLst>
              <a:ext uri="{FF2B5EF4-FFF2-40B4-BE49-F238E27FC236}">
                <a16:creationId xmlns:a16="http://schemas.microsoft.com/office/drawing/2014/main" id="{66C9D777-9642-4C4B-A428-4E3F9EDCA2F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1229" y="2049154"/>
            <a:ext cx="3639058" cy="4248743"/>
          </a:xfrm>
          <a:prstGeom prst="rect">
            <a:avLst/>
          </a:prstGeom>
        </p:spPr>
      </p:pic>
      <p:pic>
        <p:nvPicPr>
          <p:cNvPr id="8" name="Picture 7" descr="Text, letter&#10;&#10;Description automatically generated">
            <a:extLst>
              <a:ext uri="{FF2B5EF4-FFF2-40B4-BE49-F238E27FC236}">
                <a16:creationId xmlns:a16="http://schemas.microsoft.com/office/drawing/2014/main" id="{B0CC4175-8438-45FB-93D4-028AC42073B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00287" y="2049154"/>
            <a:ext cx="3591426" cy="4210638"/>
          </a:xfrm>
          <a:prstGeom prst="rect">
            <a:avLst/>
          </a:prstGeom>
        </p:spPr>
      </p:pic>
      <p:pic>
        <p:nvPicPr>
          <p:cNvPr id="11" name="Picture 10" descr="Text&#10;&#10;Description automatically generated">
            <a:extLst>
              <a:ext uri="{FF2B5EF4-FFF2-40B4-BE49-F238E27FC236}">
                <a16:creationId xmlns:a16="http://schemas.microsoft.com/office/drawing/2014/main" id="{2145A697-8BE9-4E0F-ADB6-FC43CF27542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855222" y="2044558"/>
            <a:ext cx="3620005" cy="4220164"/>
          </a:xfrm>
          <a:prstGeom prst="rect">
            <a:avLst/>
          </a:prstGeom>
        </p:spPr>
      </p:pic>
      <p:sp>
        <p:nvSpPr>
          <p:cNvPr id="13" name="TextBox 12">
            <a:extLst>
              <a:ext uri="{FF2B5EF4-FFF2-40B4-BE49-F238E27FC236}">
                <a16:creationId xmlns:a16="http://schemas.microsoft.com/office/drawing/2014/main" id="{C3128224-6AA1-4284-A1A4-55614433B981}"/>
              </a:ext>
            </a:extLst>
          </p:cNvPr>
          <p:cNvSpPr txBox="1"/>
          <p:nvPr/>
        </p:nvSpPr>
        <p:spPr>
          <a:xfrm>
            <a:off x="642286" y="1286818"/>
            <a:ext cx="367906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A2. </a:t>
            </a:r>
            <a:r>
              <a:rPr lang="en-US" sz="1600" dirty="0">
                <a:latin typeface="Times New Roman" panose="02020603050405020304" pitchFamily="18" charset="0"/>
                <a:cs typeface="Times New Roman" panose="02020603050405020304" pitchFamily="18" charset="0"/>
              </a:rPr>
              <a:t>Stay-at-home Treatments</a:t>
            </a:r>
          </a:p>
        </p:txBody>
      </p:sp>
      <p:sp>
        <p:nvSpPr>
          <p:cNvPr id="12" name="TextBox 11">
            <a:extLst>
              <a:ext uri="{FF2B5EF4-FFF2-40B4-BE49-F238E27FC236}">
                <a16:creationId xmlns:a16="http://schemas.microsoft.com/office/drawing/2014/main" id="{F868A25C-9DF9-4EC1-B915-67F123A588B9}"/>
              </a:ext>
            </a:extLst>
          </p:cNvPr>
          <p:cNvSpPr txBox="1"/>
          <p:nvPr/>
        </p:nvSpPr>
        <p:spPr>
          <a:xfrm>
            <a:off x="1346137" y="1745118"/>
            <a:ext cx="2064884"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 Christian-Framed</a:t>
            </a:r>
          </a:p>
        </p:txBody>
      </p:sp>
      <p:sp>
        <p:nvSpPr>
          <p:cNvPr id="16" name="TextBox 15">
            <a:extLst>
              <a:ext uri="{FF2B5EF4-FFF2-40B4-BE49-F238E27FC236}">
                <a16:creationId xmlns:a16="http://schemas.microsoft.com/office/drawing/2014/main" id="{44890E83-06AE-42E4-B7D0-BA1212712C9C}"/>
              </a:ext>
            </a:extLst>
          </p:cNvPr>
          <p:cNvSpPr txBox="1"/>
          <p:nvPr/>
        </p:nvSpPr>
        <p:spPr>
          <a:xfrm>
            <a:off x="5004276" y="1745118"/>
            <a:ext cx="219195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 Economy-Framed</a:t>
            </a:r>
          </a:p>
        </p:txBody>
      </p:sp>
      <p:sp>
        <p:nvSpPr>
          <p:cNvPr id="17" name="TextBox 16">
            <a:extLst>
              <a:ext uri="{FF2B5EF4-FFF2-40B4-BE49-F238E27FC236}">
                <a16:creationId xmlns:a16="http://schemas.microsoft.com/office/drawing/2014/main" id="{E36D2A76-148D-4F23-AC49-87FE655DB459}"/>
              </a:ext>
            </a:extLst>
          </p:cNvPr>
          <p:cNvSpPr txBox="1"/>
          <p:nvPr/>
        </p:nvSpPr>
        <p:spPr>
          <a:xfrm>
            <a:off x="9032073" y="1745118"/>
            <a:ext cx="128895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c) Control</a:t>
            </a:r>
          </a:p>
        </p:txBody>
      </p:sp>
    </p:spTree>
    <p:extLst>
      <p:ext uri="{BB962C8B-B14F-4D97-AF65-F5344CB8AC3E}">
        <p14:creationId xmlns:p14="http://schemas.microsoft.com/office/powerpoint/2010/main" val="11336582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86C3B6D-BBF2-4D76-AA42-8F76546CF938}"/>
              </a:ext>
            </a:extLst>
          </p:cNvPr>
          <p:cNvSpPr txBox="1"/>
          <p:nvPr/>
        </p:nvSpPr>
        <p:spPr>
          <a:xfrm>
            <a:off x="1423802" y="803811"/>
            <a:ext cx="278519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ppendix: Measures</a:t>
            </a:r>
          </a:p>
        </p:txBody>
      </p:sp>
      <p:sp>
        <p:nvSpPr>
          <p:cNvPr id="5" name="TextBox 4">
            <a:extLst>
              <a:ext uri="{FF2B5EF4-FFF2-40B4-BE49-F238E27FC236}">
                <a16:creationId xmlns:a16="http://schemas.microsoft.com/office/drawing/2014/main" id="{B9D21F70-F164-4EBE-81F5-7A4D1FDC552C}"/>
              </a:ext>
            </a:extLst>
          </p:cNvPr>
          <p:cNvSpPr txBox="1"/>
          <p:nvPr/>
        </p:nvSpPr>
        <p:spPr>
          <a:xfrm>
            <a:off x="1423803" y="1296702"/>
            <a:ext cx="8004895" cy="2893100"/>
          </a:xfrm>
          <a:prstGeom prst="rect">
            <a:avLst/>
          </a:prstGeom>
          <a:noFill/>
        </p:spPr>
        <p:txBody>
          <a:bodyPr wrap="square" rtlCol="0">
            <a:spAutoFit/>
          </a:bodyPr>
          <a:lstStyle/>
          <a:p>
            <a:endParaRPr lang="en-US" sz="1400" dirty="0">
              <a:latin typeface="Times New Roman" panose="02020603050405020304" pitchFamily="18" charset="0"/>
              <a:cs typeface="Times New Roman" panose="02020603050405020304" pitchFamily="18" charset="0"/>
            </a:endParaRPr>
          </a:p>
          <a:p>
            <a:r>
              <a:rPr lang="en-US" sz="1400" b="1" dirty="0">
                <a:latin typeface="Times New Roman" panose="02020603050405020304" pitchFamily="18" charset="0"/>
                <a:cs typeface="Times New Roman" panose="02020603050405020304" pitchFamily="18" charset="0"/>
              </a:rPr>
              <a:t>1. Identity Importance – Author created based on </a:t>
            </a:r>
            <a:r>
              <a:rPr lang="en-US" sz="1400" b="1" dirty="0" err="1">
                <a:latin typeface="Times New Roman" panose="02020603050405020304" pitchFamily="18" charset="0"/>
                <a:cs typeface="Times New Roman" panose="02020603050405020304" pitchFamily="18" charset="0"/>
              </a:rPr>
              <a:t>Postmes</a:t>
            </a:r>
            <a:r>
              <a:rPr lang="en-US" sz="1400" b="1" dirty="0">
                <a:latin typeface="Times New Roman" panose="02020603050405020304" pitchFamily="18" charset="0"/>
                <a:cs typeface="Times New Roman" panose="02020603050405020304" pitchFamily="18" charset="0"/>
              </a:rPr>
              <a:t>, et al., 2013</a:t>
            </a:r>
          </a:p>
          <a:p>
            <a:pPr marL="457200" indent="-228600">
              <a:buFont typeface="Arial" panose="020B0604020202020204" pitchFamily="34" charset="0"/>
              <a:buChar char="•"/>
            </a:pPr>
            <a:r>
              <a:rPr lang="en-US" sz="1400" dirty="0">
                <a:latin typeface="Times New Roman" panose="02020603050405020304" pitchFamily="18" charset="0"/>
                <a:cs typeface="Times New Roman" panose="02020603050405020304" pitchFamily="18" charset="0"/>
              </a:rPr>
              <a:t>How important are these issues to you? [1: Extremely Unimportant – 7: Extremely Important]</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Christianity</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Economic health of the country</a:t>
            </a:r>
          </a:p>
          <a:p>
            <a:pPr lvl="1"/>
            <a:endParaRPr lang="en-US" sz="1400" dirty="0">
              <a:latin typeface="Times New Roman" panose="02020603050405020304" pitchFamily="18" charset="0"/>
              <a:cs typeface="Times New Roman" panose="02020603050405020304" pitchFamily="18" charset="0"/>
            </a:endParaRPr>
          </a:p>
          <a:p>
            <a:r>
              <a:rPr lang="en-US" sz="1400" b="1" dirty="0">
                <a:latin typeface="Times New Roman" panose="02020603050405020304" pitchFamily="18" charset="0"/>
                <a:cs typeface="Times New Roman" panose="02020603050405020304" pitchFamily="18" charset="0"/>
              </a:rPr>
              <a:t>2. Source Trustworthiness – Adapted from Anderson, et al., 2012</a:t>
            </a:r>
          </a:p>
          <a:p>
            <a:pPr marL="457200" indent="-228600">
              <a:buFont typeface="Arial" panose="020B0604020202020204" pitchFamily="34" charset="0"/>
              <a:buChar char="•"/>
            </a:pPr>
            <a:r>
              <a:rPr lang="en-US" sz="1400" dirty="0">
                <a:latin typeface="Times New Roman" panose="02020603050405020304" pitchFamily="18" charset="0"/>
                <a:cs typeface="Times New Roman" panose="02020603050405020304" pitchFamily="18" charset="0"/>
              </a:rPr>
              <a:t>How Trustworthy are the following [1: Extremely Untrustworthy – 7: Extremely Trustworthy]</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US Public Health Servic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US Chamber of Commerc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US Senate Chaplain</a:t>
            </a:r>
          </a:p>
          <a:p>
            <a:pPr lvl="1"/>
            <a:endParaRPr lang="en-US" sz="1400" dirty="0">
              <a:latin typeface="Times New Roman" panose="02020603050405020304" pitchFamily="18" charset="0"/>
              <a:cs typeface="Times New Roman" panose="02020603050405020304" pitchFamily="18" charset="0"/>
            </a:endParaRPr>
          </a:p>
          <a:p>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448708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86C3B6D-BBF2-4D76-AA42-8F76546CF938}"/>
              </a:ext>
            </a:extLst>
          </p:cNvPr>
          <p:cNvSpPr txBox="1"/>
          <p:nvPr/>
        </p:nvSpPr>
        <p:spPr>
          <a:xfrm>
            <a:off x="1423803" y="803811"/>
            <a:ext cx="7649029"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ppendix: Measures (cont.)</a:t>
            </a:r>
          </a:p>
        </p:txBody>
      </p:sp>
      <p:sp>
        <p:nvSpPr>
          <p:cNvPr id="5" name="TextBox 4">
            <a:extLst>
              <a:ext uri="{FF2B5EF4-FFF2-40B4-BE49-F238E27FC236}">
                <a16:creationId xmlns:a16="http://schemas.microsoft.com/office/drawing/2014/main" id="{B9D21F70-F164-4EBE-81F5-7A4D1FDC552C}"/>
              </a:ext>
            </a:extLst>
          </p:cNvPr>
          <p:cNvSpPr txBox="1"/>
          <p:nvPr/>
        </p:nvSpPr>
        <p:spPr>
          <a:xfrm>
            <a:off x="1423803" y="1529874"/>
            <a:ext cx="10158597" cy="4185761"/>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3. Mask Compliance – Adapted from Dennis, et al., 2017 and Venkatesh, et al., 2003</a:t>
            </a:r>
          </a:p>
          <a:p>
            <a:pPr marL="457200" indent="-228600">
              <a:buFont typeface="Arial" panose="020B0604020202020204" pitchFamily="34" charset="0"/>
              <a:buChar char="•"/>
            </a:pPr>
            <a:r>
              <a:rPr lang="en-US" sz="1400" dirty="0">
                <a:latin typeface="Times New Roman" panose="02020603050405020304" pitchFamily="18" charset="0"/>
                <a:cs typeface="Times New Roman" panose="02020603050405020304" pitchFamily="18" charset="0"/>
              </a:rPr>
              <a:t>Please rate your agreement with each of the following statements [0: Strongly Disagree – 100: Strongly Agree] </a:t>
            </a:r>
            <a:endParaRPr lang="en-US" sz="1400" b="1" dirty="0">
              <a:latin typeface="Times New Roman" panose="02020603050405020304" pitchFamily="18" charset="0"/>
              <a:cs typeface="Times New Roman" panose="02020603050405020304" pitchFamily="18" charset="0"/>
            </a:endParaRP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intend to wear a mask whenever I am in public and around other peop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predict I will wear a mask whenever I am in public and around other peop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plan to wear a mask whenever I am in public and around other peop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Wearing a mask whenever I am in public and around other people will be part of my usual routin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will recommend to others that they wear a mask whenever I am in public and around other peop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will advocate for wearing a mask whenever I am in public and around other peop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Wearing a mask whenever I am in public and around other people is an appropriate thing to do</a:t>
            </a:r>
          </a:p>
          <a:p>
            <a:endParaRPr lang="en-US" sz="1400" b="1" dirty="0">
              <a:latin typeface="Times New Roman" panose="02020603050405020304" pitchFamily="18" charset="0"/>
              <a:cs typeface="Times New Roman" panose="02020603050405020304" pitchFamily="18" charset="0"/>
            </a:endParaRPr>
          </a:p>
          <a:p>
            <a:r>
              <a:rPr lang="en-US" sz="1400" b="1" dirty="0">
                <a:latin typeface="Times New Roman" panose="02020603050405020304" pitchFamily="18" charset="0"/>
                <a:cs typeface="Times New Roman" panose="02020603050405020304" pitchFamily="18" charset="0"/>
              </a:rPr>
              <a:t>4. Stay-at-home Compliance – Adapted from Dennis, et al., 2017 and Venkatesh, et al., 2003</a:t>
            </a:r>
          </a:p>
          <a:p>
            <a:pPr marL="457200" indent="-228600">
              <a:buFont typeface="Arial" panose="020B0604020202020204" pitchFamily="34" charset="0"/>
              <a:buChar char="•"/>
            </a:pPr>
            <a:r>
              <a:rPr lang="en-US" sz="1400" dirty="0">
                <a:latin typeface="Times New Roman" panose="02020603050405020304" pitchFamily="18" charset="0"/>
                <a:cs typeface="Times New Roman" panose="02020603050405020304" pitchFamily="18" charset="0"/>
              </a:rPr>
              <a:t>Please rate your agreement with each of the following statements [0: Strongly Disagree – 100: Strongly Agree]   </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intend to remain at home as much as possib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predict I will remain at home as much as possib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plan to remain at home as much as possib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Remaining at home as much as possible will be part of my usual routin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will recommend remaining at home as much as possible to others</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I will advocate for remaining at home as much as possible</a:t>
            </a:r>
          </a:p>
          <a:p>
            <a:pPr marL="742950" lvl="1" indent="-285750">
              <a:buFont typeface="Garamond" panose="02020404030301010803" pitchFamily="18" charset="0"/>
              <a:buChar char="−"/>
            </a:pPr>
            <a:r>
              <a:rPr lang="en-US" sz="1400" dirty="0">
                <a:latin typeface="Times New Roman" panose="02020603050405020304" pitchFamily="18" charset="0"/>
                <a:cs typeface="Times New Roman" panose="02020603050405020304" pitchFamily="18" charset="0"/>
              </a:rPr>
              <a:t>Remaining at home as much as possible is an appropriate thing to do</a:t>
            </a:r>
          </a:p>
        </p:txBody>
      </p:sp>
    </p:spTree>
    <p:extLst>
      <p:ext uri="{BB962C8B-B14F-4D97-AF65-F5344CB8AC3E}">
        <p14:creationId xmlns:p14="http://schemas.microsoft.com/office/powerpoint/2010/main" val="15119869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581187" y="1587688"/>
            <a:ext cx="4121623" cy="4185761"/>
          </a:xfrm>
          <a:prstGeom prst="rect">
            <a:avLst/>
          </a:prstGeom>
          <a:noFill/>
        </p:spPr>
        <p:txBody>
          <a:bodyPr wrap="square" rtlCol="0">
            <a:spAutoFit/>
          </a:bodyPr>
          <a:lstStyle/>
          <a:p>
            <a:pPr indent="457200" algn="just"/>
            <a:r>
              <a:rPr lang="en-US" sz="1400" dirty="0">
                <a:latin typeface="Times New Roman" panose="02020603050405020304" pitchFamily="18" charset="0"/>
                <a:cs typeface="Times New Roman" panose="02020603050405020304" pitchFamily="18" charset="0"/>
              </a:rPr>
              <a:t>We used an Exploratory Factor Analysis in SPSS to assess whether the question items loaded on constructs as intended. We specified four factors, theorizing that the compliance outcome, and two identities were distinct factors. The three trust measures are separate constructs, but all are influenced by an individual’s underlying Disposition to Trust and thus are likely to share some commonality. </a:t>
            </a:r>
          </a:p>
          <a:p>
            <a:pPr algn="just"/>
            <a:endParaRPr lang="en-US" sz="1400" dirty="0">
              <a:latin typeface="Times New Roman" panose="02020603050405020304" pitchFamily="18" charset="0"/>
              <a:cs typeface="Times New Roman" panose="02020603050405020304" pitchFamily="18" charset="0"/>
            </a:endParaRPr>
          </a:p>
          <a:p>
            <a:pPr indent="457200" algn="just"/>
            <a:r>
              <a:rPr lang="en-US" sz="1400" dirty="0">
                <a:latin typeface="Times New Roman" panose="02020603050405020304" pitchFamily="18" charset="0"/>
                <a:cs typeface="Times New Roman" panose="02020603050405020304" pitchFamily="18" charset="0"/>
              </a:rPr>
              <a:t>The results show that the four-factor solution fits the data as expected. All seven compliance items load well on the first factor (with loadings &gt; .80). Likewise, the two identity questions load on separate factors with loadings above .90. The three trust factors load on one factor, but the loadings are not all uniformly high, thus indicating the effects of the individual’s fundamental disposition to trust as well as the separate effects of the three trust targets. The cross loadings are small, except for Trust in PHS on factor one (loading = .473).</a:t>
            </a:r>
          </a:p>
        </p:txBody>
      </p:sp>
      <p:sp>
        <p:nvSpPr>
          <p:cNvPr id="7" name="TextBox 6">
            <a:extLst>
              <a:ext uri="{FF2B5EF4-FFF2-40B4-BE49-F238E27FC236}">
                <a16:creationId xmlns:a16="http://schemas.microsoft.com/office/drawing/2014/main" id="{A86C3B6D-BBF2-4D76-AA42-8F76546CF938}"/>
              </a:ext>
            </a:extLst>
          </p:cNvPr>
          <p:cNvSpPr txBox="1"/>
          <p:nvPr/>
        </p:nvSpPr>
        <p:spPr>
          <a:xfrm>
            <a:off x="1581187" y="1079431"/>
            <a:ext cx="278519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ppendix: Factor Analysis </a:t>
            </a:r>
          </a:p>
        </p:txBody>
      </p:sp>
      <p:pic>
        <p:nvPicPr>
          <p:cNvPr id="8" name="Picture 7">
            <a:extLst>
              <a:ext uri="{FF2B5EF4-FFF2-40B4-BE49-F238E27FC236}">
                <a16:creationId xmlns:a16="http://schemas.microsoft.com/office/drawing/2014/main" id="{9115673C-CB0E-4756-936B-873DD3D3C917}"/>
              </a:ext>
            </a:extLst>
          </p:cNvPr>
          <p:cNvPicPr>
            <a:picLocks noChangeAspect="1"/>
          </p:cNvPicPr>
          <p:nvPr/>
        </p:nvPicPr>
        <p:blipFill rotWithShape="1">
          <a:blip r:embed="rId2"/>
          <a:srcRect r="36924"/>
          <a:stretch/>
        </p:blipFill>
        <p:spPr>
          <a:xfrm>
            <a:off x="6228367" y="1858375"/>
            <a:ext cx="4631808" cy="3644385"/>
          </a:xfrm>
          <a:prstGeom prst="rect">
            <a:avLst/>
          </a:prstGeom>
        </p:spPr>
      </p:pic>
    </p:spTree>
    <p:extLst>
      <p:ext uri="{BB962C8B-B14F-4D97-AF65-F5344CB8AC3E}">
        <p14:creationId xmlns:p14="http://schemas.microsoft.com/office/powerpoint/2010/main" val="8183587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899313" y="2305615"/>
            <a:ext cx="10393374" cy="2246769"/>
          </a:xfrm>
          <a:prstGeom prst="rect">
            <a:avLst/>
          </a:prstGeom>
        </p:spPr>
        <p:txBody>
          <a:bodyPr wrap="square">
            <a:spAutoFit/>
          </a:bodyPr>
          <a:lstStyle/>
          <a:p>
            <a:pPr lvl="0" algn="just"/>
            <a:r>
              <a:rPr lang="en-US" sz="1400" b="1" dirty="0">
                <a:latin typeface="Times New Roman" panose="02020603050405020304" pitchFamily="18" charset="0"/>
                <a:cs typeface="Times New Roman" panose="02020603050405020304" pitchFamily="18" charset="0"/>
              </a:rPr>
              <a:t>References</a:t>
            </a:r>
          </a:p>
          <a:p>
            <a:pPr lvl="0" algn="just"/>
            <a:endParaRPr lang="en-US" sz="1400" b="1" dirty="0">
              <a:latin typeface="Times New Roman" panose="02020603050405020304" pitchFamily="18" charset="0"/>
              <a:cs typeface="Times New Roman" panose="02020603050405020304" pitchFamily="18" charset="0"/>
            </a:endParaRPr>
          </a:p>
          <a:p>
            <a:pPr lvl="0" algn="just"/>
            <a:r>
              <a:rPr lang="en-US" sz="1400" dirty="0">
                <a:latin typeface="Times New Roman" panose="02020603050405020304" pitchFamily="18" charset="0"/>
                <a:cs typeface="Times New Roman" panose="02020603050405020304" pitchFamily="18" charset="0"/>
              </a:rPr>
              <a:t>Anderson, E., Siegel, E., White, D., and Barret, L.B. (2012). Out of Sight but Not Out of Mind: Unseen Affective Faces Influence Evaluations </a:t>
            </a:r>
          </a:p>
          <a:p>
            <a:pPr lvl="0" algn="just"/>
            <a:r>
              <a:rPr lang="en-US" sz="1400" dirty="0">
                <a:latin typeface="Times New Roman" panose="02020603050405020304" pitchFamily="18" charset="0"/>
                <a:cs typeface="Times New Roman" panose="02020603050405020304" pitchFamily="18" charset="0"/>
              </a:rPr>
              <a:t>          and Social Impressions. </a:t>
            </a:r>
            <a:r>
              <a:rPr lang="en-US" sz="1400" i="1" dirty="0">
                <a:latin typeface="Times New Roman" panose="02020603050405020304" pitchFamily="18" charset="0"/>
                <a:cs typeface="Times New Roman" panose="02020603050405020304" pitchFamily="18" charset="0"/>
              </a:rPr>
              <a:t>Emotion</a:t>
            </a:r>
            <a:r>
              <a:rPr lang="en-US" sz="1400" dirty="0">
                <a:latin typeface="Times New Roman" panose="02020603050405020304" pitchFamily="18" charset="0"/>
                <a:cs typeface="Times New Roman" panose="02020603050405020304" pitchFamily="18" charset="0"/>
              </a:rPr>
              <a:t>, 12(6), 1210-1221. </a:t>
            </a:r>
          </a:p>
          <a:p>
            <a:pPr marL="457200" lvl="0" indent="-457200" algn="just"/>
            <a:r>
              <a:rPr lang="en-US" sz="1400" dirty="0">
                <a:latin typeface="Times New Roman" panose="02020603050405020304" pitchFamily="18" charset="0"/>
                <a:cs typeface="Times New Roman" panose="02020603050405020304" pitchFamily="18" charset="0"/>
              </a:rPr>
              <a:t>Dennis, A.R., Clay, P.F. and </a:t>
            </a:r>
            <a:r>
              <a:rPr lang="en-US" sz="1400" dirty="0" err="1">
                <a:latin typeface="Times New Roman" panose="02020603050405020304" pitchFamily="18" charset="0"/>
                <a:cs typeface="Times New Roman" panose="02020603050405020304" pitchFamily="18" charset="0"/>
              </a:rPr>
              <a:t>Ko</a:t>
            </a:r>
            <a:r>
              <a:rPr lang="en-US" sz="1400" dirty="0">
                <a:latin typeface="Times New Roman" panose="02020603050405020304" pitchFamily="18" charset="0"/>
                <a:cs typeface="Times New Roman" panose="02020603050405020304" pitchFamily="18" charset="0"/>
              </a:rPr>
              <a:t>, D.K. (2017). From Individual Cognition to Social Ecosystem: A Structuration Model of Enterprise Systems Use. </a:t>
            </a:r>
            <a:r>
              <a:rPr lang="en-US" sz="1400" i="1" dirty="0">
                <a:latin typeface="Times New Roman" panose="02020603050405020304" pitchFamily="18" charset="0"/>
                <a:cs typeface="Times New Roman" panose="02020603050405020304" pitchFamily="18" charset="0"/>
              </a:rPr>
              <a:t>AIS Transactions on Human Computer Interaction</a:t>
            </a:r>
            <a:r>
              <a:rPr lang="en-US" sz="1400" dirty="0">
                <a:latin typeface="Times New Roman" panose="02020603050405020304" pitchFamily="18" charset="0"/>
                <a:cs typeface="Times New Roman" panose="02020603050405020304" pitchFamily="18" charset="0"/>
              </a:rPr>
              <a:t>, 9(4), 301-338.</a:t>
            </a:r>
          </a:p>
          <a:p>
            <a:pPr marL="457200" indent="-457200" algn="just"/>
            <a:r>
              <a:rPr lang="en-US" sz="1400" dirty="0" err="1">
                <a:latin typeface="Times New Roman" panose="02020603050405020304" pitchFamily="18" charset="0"/>
                <a:cs typeface="Times New Roman" panose="02020603050405020304" pitchFamily="18" charset="0"/>
              </a:rPr>
              <a:t>Postmes</a:t>
            </a:r>
            <a:r>
              <a:rPr lang="en-US" sz="1400" dirty="0">
                <a:latin typeface="Times New Roman" panose="02020603050405020304" pitchFamily="18" charset="0"/>
                <a:cs typeface="Times New Roman" panose="02020603050405020304" pitchFamily="18" charset="0"/>
              </a:rPr>
              <a:t>, T., Haslam, S. A., &amp; </a:t>
            </a:r>
            <a:r>
              <a:rPr lang="en-US" sz="1400" dirty="0" err="1">
                <a:latin typeface="Times New Roman" panose="02020603050405020304" pitchFamily="18" charset="0"/>
                <a:cs typeface="Times New Roman" panose="02020603050405020304" pitchFamily="18" charset="0"/>
              </a:rPr>
              <a:t>Jans</a:t>
            </a:r>
            <a:r>
              <a:rPr lang="en-US" sz="1400" dirty="0">
                <a:latin typeface="Times New Roman" panose="02020603050405020304" pitchFamily="18" charset="0"/>
                <a:cs typeface="Times New Roman" panose="02020603050405020304" pitchFamily="18" charset="0"/>
              </a:rPr>
              <a:t>, L. (2013). A single‐item measure of social identification: Reliability, validity, and utility. </a:t>
            </a:r>
            <a:r>
              <a:rPr lang="en-US" sz="1400" i="1" dirty="0">
                <a:latin typeface="Times New Roman" panose="02020603050405020304" pitchFamily="18" charset="0"/>
                <a:cs typeface="Times New Roman" panose="02020603050405020304" pitchFamily="18" charset="0"/>
              </a:rPr>
              <a:t>British Journal of Social Psychology, 52</a:t>
            </a:r>
            <a:r>
              <a:rPr lang="en-US" sz="1400" dirty="0">
                <a:latin typeface="Times New Roman" panose="02020603050405020304" pitchFamily="18" charset="0"/>
                <a:cs typeface="Times New Roman" panose="02020603050405020304" pitchFamily="18" charset="0"/>
              </a:rPr>
              <a:t>(4), 597-617.</a:t>
            </a:r>
          </a:p>
          <a:p>
            <a:pPr marL="457200" lvl="0" indent="-457200" algn="just"/>
            <a:r>
              <a:rPr lang="en-US" sz="1400" dirty="0">
                <a:latin typeface="Times New Roman" panose="02020603050405020304" pitchFamily="18" charset="0"/>
                <a:cs typeface="Times New Roman" panose="02020603050405020304" pitchFamily="18" charset="0"/>
              </a:rPr>
              <a:t>Venkatesh, V., Morris, M.G., Davis, G.B. and Davis, F.D. (2003). User Acceptance of Information Technology: Toward a Unified View. </a:t>
            </a:r>
            <a:r>
              <a:rPr lang="en-US" sz="1400" i="1" dirty="0">
                <a:latin typeface="Times New Roman" panose="02020603050405020304" pitchFamily="18" charset="0"/>
                <a:cs typeface="Times New Roman" panose="02020603050405020304" pitchFamily="18" charset="0"/>
              </a:rPr>
              <a:t>MIS Quarterly</a:t>
            </a:r>
            <a:r>
              <a:rPr lang="en-US" sz="1400" dirty="0">
                <a:latin typeface="Times New Roman" panose="02020603050405020304" pitchFamily="18" charset="0"/>
                <a:cs typeface="Times New Roman" panose="02020603050405020304" pitchFamily="18" charset="0"/>
              </a:rPr>
              <a:t>, 27(3), 425-478</a:t>
            </a:r>
          </a:p>
        </p:txBody>
      </p:sp>
    </p:spTree>
    <p:extLst>
      <p:ext uri="{BB962C8B-B14F-4D97-AF65-F5344CB8AC3E}">
        <p14:creationId xmlns:p14="http://schemas.microsoft.com/office/powerpoint/2010/main" val="10862134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20FF0976DC1C504D9414CC8CB1DA5D12" ma:contentTypeVersion="13" ma:contentTypeDescription="Create a new document." ma:contentTypeScope="" ma:versionID="2d23ecf37d59e6448dacf21a69b0049c">
  <xsd:schema xmlns:xsd="http://www.w3.org/2001/XMLSchema" xmlns:xs="http://www.w3.org/2001/XMLSchema" xmlns:p="http://schemas.microsoft.com/office/2006/metadata/properties" xmlns:ns3="4e110180-cf0f-44c7-858f-1d66aeeba36b" xmlns:ns4="e8bf79c9-1a07-4703-aae4-15881a593039" targetNamespace="http://schemas.microsoft.com/office/2006/metadata/properties" ma:root="true" ma:fieldsID="30599dda63187bf3a38355db346e8ccc" ns3:_="" ns4:_="">
    <xsd:import namespace="4e110180-cf0f-44c7-858f-1d66aeeba36b"/>
    <xsd:import namespace="e8bf79c9-1a07-4703-aae4-15881a59303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3:MediaServiceLocation"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e110180-cf0f-44c7-858f-1d66aeeba36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e8bf79c9-1a07-4703-aae4-15881a593039"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59F10F60-090C-4994-868E-D8CF4942232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e110180-cf0f-44c7-858f-1d66aeeba36b"/>
    <ds:schemaRef ds:uri="e8bf79c9-1a07-4703-aae4-15881a59303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1FEB77E-2FFD-469F-8E98-982378828487}">
  <ds:schemaRefs>
    <ds:schemaRef ds:uri="http://schemas.microsoft.com/sharepoint/v3/contenttype/forms"/>
  </ds:schemaRefs>
</ds:datastoreItem>
</file>

<file path=customXml/itemProps3.xml><?xml version="1.0" encoding="utf-8"?>
<ds:datastoreItem xmlns:ds="http://schemas.openxmlformats.org/officeDocument/2006/customXml" ds:itemID="{515F7352-BD17-400E-9E32-24D600C3658E}">
  <ds:schemaRefs>
    <ds:schemaRef ds:uri="http://schemas.microsoft.com/office/2006/documentManagement/types"/>
    <ds:schemaRef ds:uri="http://purl.org/dc/terms/"/>
    <ds:schemaRef ds:uri="http://schemas.openxmlformats.org/package/2006/metadata/core-properties"/>
    <ds:schemaRef ds:uri="http://purl.org/dc/dcmitype/"/>
    <ds:schemaRef ds:uri="http://schemas.microsoft.com/office/infopath/2007/PartnerControls"/>
    <ds:schemaRef ds:uri="http://purl.org/dc/elements/1.1/"/>
    <ds:schemaRef ds:uri="http://schemas.microsoft.com/office/2006/metadata/properties"/>
    <ds:schemaRef ds:uri="e8bf79c9-1a07-4703-aae4-15881a593039"/>
    <ds:schemaRef ds:uri="4e110180-cf0f-44c7-858f-1d66aeeba36b"/>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otalTime>5039</TotalTime>
  <Words>785</Words>
  <Application>Microsoft Office PowerPoint</Application>
  <PresentationFormat>Widescreen</PresentationFormat>
  <Paragraphs>52</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Garamond</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er Dennis</dc:creator>
  <cp:lastModifiedBy>Dennis, Alan R.</cp:lastModifiedBy>
  <cp:revision>45</cp:revision>
  <dcterms:created xsi:type="dcterms:W3CDTF">2020-12-27T23:06:21Z</dcterms:created>
  <dcterms:modified xsi:type="dcterms:W3CDTF">2021-02-09T11:59: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0FF0976DC1C504D9414CC8CB1DA5D12</vt:lpwstr>
  </property>
</Properties>
</file>